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200" d="100"/>
          <a:sy n="200" d="100"/>
        </p:scale>
        <p:origin x="2370" y="44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mtang\AppData\Local\Temp\C3%20quantific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pPr>
              <a:gradFill>
                <a:gsLst>
                  <a:gs pos="0">
                    <a:schemeClr val="accent1">
                      <a:tint val="66000"/>
                      <a:satMod val="160000"/>
                    </a:schemeClr>
                  </a:gs>
                  <a:gs pos="50000">
                    <a:schemeClr val="accent1">
                      <a:tint val="44500"/>
                      <a:satMod val="160000"/>
                    </a:schemeClr>
                  </a:gs>
                  <a:gs pos="100000">
                    <a:schemeClr val="accent1">
                      <a:tint val="23500"/>
                      <a:satMod val="160000"/>
                    </a:schemeClr>
                  </a:gs>
                </a:gsLst>
                <a:lin ang="5400000" scaled="0"/>
              </a:gradFill>
            </c:spPr>
          </c:marker>
          <c:xVal>
            <c:numRef>
              <c:f>Sheet1!$B$3:$B$32</c:f>
              <c:numCache>
                <c:formatCode>0</c:formatCode>
                <c:ptCount val="30"/>
                <c:pt idx="0">
                  <c:v>239.09573399999994</c:v>
                </c:pt>
                <c:pt idx="1">
                  <c:v>282.50393399999996</c:v>
                </c:pt>
                <c:pt idx="2">
                  <c:v>196.98978</c:v>
                </c:pt>
                <c:pt idx="3">
                  <c:v>341.539086</c:v>
                </c:pt>
                <c:pt idx="4">
                  <c:v>246.47512799999998</c:v>
                </c:pt>
                <c:pt idx="5">
                  <c:v>292.48781999999994</c:v>
                </c:pt>
                <c:pt idx="6">
                  <c:v>314.62600199999997</c:v>
                </c:pt>
                <c:pt idx="7">
                  <c:v>295.52639399999998</c:v>
                </c:pt>
                <c:pt idx="8">
                  <c:v>407.95363199999991</c:v>
                </c:pt>
                <c:pt idx="9">
                  <c:v>287.27883599999996</c:v>
                </c:pt>
                <c:pt idx="10">
                  <c:v>468.72511200000008</c:v>
                </c:pt>
                <c:pt idx="11">
                  <c:v>218.69387999999995</c:v>
                </c:pt>
                <c:pt idx="12">
                  <c:v>356.29787399999998</c:v>
                </c:pt>
                <c:pt idx="13">
                  <c:v>249.51370199999997</c:v>
                </c:pt>
                <c:pt idx="14">
                  <c:v>237.35940599999992</c:v>
                </c:pt>
                <c:pt idx="15">
                  <c:v>312.02150999999998</c:v>
                </c:pt>
                <c:pt idx="16">
                  <c:v>466.98878400000001</c:v>
                </c:pt>
                <c:pt idx="17">
                  <c:v>335.02785599999993</c:v>
                </c:pt>
                <c:pt idx="18">
                  <c:v>355.86379199999993</c:v>
                </c:pt>
                <c:pt idx="19">
                  <c:v>286.84475399999997</c:v>
                </c:pt>
                <c:pt idx="20">
                  <c:v>348.48439799999994</c:v>
                </c:pt>
                <c:pt idx="21">
                  <c:v>243.87063599999993</c:v>
                </c:pt>
                <c:pt idx="22">
                  <c:v>301.60354199999995</c:v>
                </c:pt>
                <c:pt idx="23">
                  <c:v>245.60696399999995</c:v>
                </c:pt>
                <c:pt idx="24">
                  <c:v>229.11184799999995</c:v>
                </c:pt>
                <c:pt idx="25">
                  <c:v>371.92482599999994</c:v>
                </c:pt>
                <c:pt idx="26">
                  <c:v>424.44874799999997</c:v>
                </c:pt>
                <c:pt idx="27">
                  <c:v>292.92190199999999</c:v>
                </c:pt>
                <c:pt idx="28">
                  <c:v>250.38186599999995</c:v>
                </c:pt>
                <c:pt idx="29">
                  <c:v>230.84817599999997</c:v>
                </c:pt>
              </c:numCache>
            </c:numRef>
          </c:xVal>
          <c:yVal>
            <c:numRef>
              <c:f>Sheet1!$C$3:$C$32</c:f>
              <c:numCache>
                <c:formatCode>General</c:formatCode>
                <c:ptCount val="30"/>
                <c:pt idx="0">
                  <c:v>0.48149999999999998</c:v>
                </c:pt>
                <c:pt idx="1">
                  <c:v>0.52</c:v>
                </c:pt>
                <c:pt idx="2">
                  <c:v>0.46450000000000002</c:v>
                </c:pt>
                <c:pt idx="3">
                  <c:v>0.50249999999999995</c:v>
                </c:pt>
                <c:pt idx="4">
                  <c:v>0.63200000000000001</c:v>
                </c:pt>
                <c:pt idx="5">
                  <c:v>0.82050000000000001</c:v>
                </c:pt>
                <c:pt idx="6">
                  <c:v>0.59750000000000003</c:v>
                </c:pt>
                <c:pt idx="7">
                  <c:v>0.82250000000000001</c:v>
                </c:pt>
                <c:pt idx="8">
                  <c:v>0.71050000000000002</c:v>
                </c:pt>
                <c:pt idx="9">
                  <c:v>0.45600000000000002</c:v>
                </c:pt>
                <c:pt idx="10">
                  <c:v>0.79200000000000004</c:v>
                </c:pt>
                <c:pt idx="11">
                  <c:v>0.46850000000000003</c:v>
                </c:pt>
                <c:pt idx="12">
                  <c:v>0.74250000000000005</c:v>
                </c:pt>
                <c:pt idx="13">
                  <c:v>0.38700000000000001</c:v>
                </c:pt>
                <c:pt idx="14">
                  <c:v>0.48799999999999999</c:v>
                </c:pt>
                <c:pt idx="15">
                  <c:v>0.45850000000000002</c:v>
                </c:pt>
                <c:pt idx="16">
                  <c:v>0.79749999999999999</c:v>
                </c:pt>
                <c:pt idx="17">
                  <c:v>0.65449999999999997</c:v>
                </c:pt>
                <c:pt idx="18">
                  <c:v>0.5665</c:v>
                </c:pt>
                <c:pt idx="19">
                  <c:v>0.63900000000000001</c:v>
                </c:pt>
                <c:pt idx="20">
                  <c:v>0.51900000000000002</c:v>
                </c:pt>
                <c:pt idx="21">
                  <c:v>0.47699999999999998</c:v>
                </c:pt>
                <c:pt idx="22">
                  <c:v>0.44900000000000001</c:v>
                </c:pt>
                <c:pt idx="23">
                  <c:v>0.49049999999999999</c:v>
                </c:pt>
                <c:pt idx="24">
                  <c:v>0.4985</c:v>
                </c:pt>
                <c:pt idx="25">
                  <c:v>0.61199999999999999</c:v>
                </c:pt>
                <c:pt idx="26">
                  <c:v>0.61699999999999999</c:v>
                </c:pt>
                <c:pt idx="27">
                  <c:v>0.59499999999999997</c:v>
                </c:pt>
                <c:pt idx="28">
                  <c:v>0.46250000000000002</c:v>
                </c:pt>
                <c:pt idx="29">
                  <c:v>0.420499999999999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1897984"/>
        <c:axId val="132911104"/>
      </c:scatterChart>
      <c:valAx>
        <c:axId val="151897984"/>
        <c:scaling>
          <c:orientation val="minMax"/>
        </c:scaling>
        <c:delete val="0"/>
        <c:axPos val="b"/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32911104"/>
        <c:crosses val="autoZero"/>
        <c:crossBetween val="midCat"/>
      </c:valAx>
      <c:valAx>
        <c:axId val="1329111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189798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D4E94A-E919-45CE-B46F-09760D250E98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FAD211-0E3D-4BD5-97BA-E2FFCA48A13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14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3A9F7-CAD4-431A-B599-5C08CBA19286}" type="datetimeFigureOut">
              <a:rPr lang="en-US" smtClean="0"/>
              <a:pPr/>
              <a:t>9/26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59CEA-777E-43CE-81F5-D000DF9018E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3822721467"/>
              </p:ext>
            </p:extLst>
          </p:nvPr>
        </p:nvGraphicFramePr>
        <p:xfrm>
          <a:off x="1268760" y="4078977"/>
          <a:ext cx="410445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itle 1"/>
          <p:cNvSpPr txBox="1">
            <a:spLocks/>
          </p:cNvSpPr>
          <p:nvPr/>
        </p:nvSpPr>
        <p:spPr>
          <a:xfrm>
            <a:off x="374059" y="7164288"/>
            <a:ext cx="6164442" cy="1800200"/>
          </a:xfrm>
          <a:prstGeom prst="rect">
            <a:avLst/>
          </a:prstGeom>
        </p:spPr>
        <p:txBody>
          <a:bodyPr>
            <a:norm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upplemental Figure </a:t>
            </a:r>
            <a:r>
              <a:rPr lang="en-GB" sz="1200" b="1" noProof="0" dirty="0">
                <a:latin typeface="+mj-lt"/>
                <a:ea typeface="+mj-ea"/>
                <a:cs typeface="+mj-cs"/>
              </a:rPr>
              <a:t>3</a:t>
            </a:r>
            <a:r>
              <a:rPr kumimoji="0" lang="en-GB" sz="12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</a:t>
            </a:r>
            <a:r>
              <a:rPr kumimoji="0" lang="en-GB" sz="12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Chimeric </a:t>
            </a:r>
            <a:r>
              <a:rPr kumimoji="0" lang="en-GB" sz="120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H</a:t>
            </a: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binds to </a:t>
            </a:r>
            <a:r>
              <a:rPr lang="en-GB" sz="1200" dirty="0" err="1" smtClean="0">
                <a:latin typeface="+mj-lt"/>
                <a:ea typeface="+mj-ea"/>
                <a:cs typeface="+mj-cs"/>
              </a:rPr>
              <a:t>fHbp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. Far Western analysis of sera from wild-type and transgenic mice (genotype indicated) to lysates from </a:t>
            </a:r>
            <a:r>
              <a:rPr lang="en-GB" sz="1200" i="1" dirty="0" smtClean="0">
                <a:latin typeface="+mj-lt"/>
                <a:ea typeface="+mj-ea"/>
                <a:cs typeface="+mj-cs"/>
              </a:rPr>
              <a:t>N. </a:t>
            </a:r>
            <a:r>
              <a:rPr lang="en-GB" sz="1200" i="1" dirty="0" err="1" smtClean="0">
                <a:latin typeface="+mj-lt"/>
                <a:ea typeface="+mj-ea"/>
                <a:cs typeface="+mj-cs"/>
              </a:rPr>
              <a:t>meningitidis</a:t>
            </a:r>
            <a:r>
              <a:rPr lang="en-GB" sz="1200" i="1" dirty="0" smtClean="0">
                <a:latin typeface="+mj-lt"/>
                <a:ea typeface="+mj-ea"/>
                <a:cs typeface="+mj-cs"/>
              </a:rPr>
              <a:t> 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strain MC58 or the isogenic </a:t>
            </a:r>
            <a:r>
              <a:rPr lang="en-GB" sz="1200" dirty="0" err="1" smtClean="0">
                <a:latin typeface="+mj-lt"/>
                <a:ea typeface="+mj-ea"/>
                <a:cs typeface="+mj-cs"/>
              </a:rPr>
              <a:t>fHbp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 mutant, and the corresponding recombinant V1.1 protein. Sizes of a mol. mass marker are shown.  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 smtClean="0">
                <a:latin typeface="+mj-lt"/>
                <a:ea typeface="+mj-ea"/>
                <a:cs typeface="+mj-cs"/>
              </a:rPr>
              <a:t>B </a:t>
            </a: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elationship between fH and C3 levels in transgenic mice. </a:t>
            </a:r>
            <a:r>
              <a:rPr kumimoji="0" lang="en-GB" sz="120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H</a:t>
            </a:r>
            <a:r>
              <a:rPr kumimoji="0" lang="en-GB" sz="120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shown as relative OD,</a:t>
            </a:r>
            <a:r>
              <a:rPr kumimoji="0" lang="en-GB" sz="120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as determined by ELISA. 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Due to </a:t>
            </a:r>
            <a:r>
              <a:rPr lang="en-GB" sz="1200" dirty="0" err="1" smtClean="0">
                <a:latin typeface="+mj-lt"/>
                <a:ea typeface="+mj-ea"/>
                <a:cs typeface="+mj-cs"/>
              </a:rPr>
              <a:t>chimeric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 nature of </a:t>
            </a:r>
            <a:r>
              <a:rPr lang="en-GB" sz="1200" dirty="0" err="1" smtClean="0">
                <a:latin typeface="+mj-lt"/>
                <a:ea typeface="+mj-ea"/>
                <a:cs typeface="+mj-cs"/>
              </a:rPr>
              <a:t>fH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 from these mice, it was not possible to determine the absolute levels of </a:t>
            </a:r>
            <a:r>
              <a:rPr lang="en-GB" sz="1200" dirty="0" err="1" smtClean="0">
                <a:latin typeface="+mj-lt"/>
                <a:ea typeface="+mj-ea"/>
                <a:cs typeface="+mj-cs"/>
              </a:rPr>
              <a:t>fH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 . The average C3 level in non-transgenic, C57/Bl6 mice was 225 </a:t>
            </a:r>
            <a:r>
              <a:rPr lang="en-GB" sz="1200" dirty="0" smtClean="0">
                <a:latin typeface="Symbol" pitchFamily="18" charset="2"/>
                <a:ea typeface="+mj-ea"/>
                <a:cs typeface="+mj-cs"/>
              </a:rPr>
              <a:t>m</a:t>
            </a:r>
            <a:r>
              <a:rPr lang="en-GB" sz="1200" dirty="0" smtClean="0">
                <a:latin typeface="+mj-lt"/>
                <a:ea typeface="+mj-ea"/>
                <a:cs typeface="+mj-cs"/>
              </a:rPr>
              <a:t>g/ml.  </a:t>
            </a:r>
            <a:endParaRPr kumimoji="0" lang="en-GB" sz="120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348880" y="6743273"/>
            <a:ext cx="18348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Serum C3 levels (</a:t>
            </a:r>
            <a:r>
              <a:rPr lang="en-GB" sz="1200" dirty="0" smtClean="0">
                <a:latin typeface="Symbol" pitchFamily="18" charset="2"/>
              </a:rPr>
              <a:t>m</a:t>
            </a:r>
            <a:r>
              <a:rPr lang="en-GB" sz="1200" dirty="0" smtClean="0"/>
              <a:t>g/ml)</a:t>
            </a:r>
            <a:endParaRPr lang="en-GB" sz="1200" dirty="0"/>
          </a:p>
        </p:txBody>
      </p:sp>
      <p:sp>
        <p:nvSpPr>
          <p:cNvPr id="5" name="Rectangle 4"/>
          <p:cNvSpPr/>
          <p:nvPr/>
        </p:nvSpPr>
        <p:spPr>
          <a:xfrm rot="16200000">
            <a:off x="158152" y="5117576"/>
            <a:ext cx="19442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Relative fH levels (O.D.)</a:t>
            </a:r>
            <a:endParaRPr lang="en-GB" sz="1200" dirty="0"/>
          </a:p>
        </p:txBody>
      </p:sp>
      <p:pic>
        <p:nvPicPr>
          <p:cNvPr id="6" name="Picture 5"/>
          <p:cNvPicPr/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6305"/>
          <a:stretch/>
        </p:blipFill>
        <p:spPr>
          <a:xfrm>
            <a:off x="1234024" y="2195736"/>
            <a:ext cx="4211200" cy="1071295"/>
          </a:xfrm>
          <a:prstGeom prst="rect">
            <a:avLst/>
          </a:prstGeom>
          <a:extLst>
            <a:ext uri="{FAA26D3D-D897-4be2-8F04-BA451C77F1D7}">
              <ma14:placeholderFlag xmlns="" xmlns:wpc="http://schemas.microsoft.com/office/word/2010/wordprocessingCanvas" xmlns:mo="http://schemas.microsoft.com/office/mac/office/2008/main" xmlns:mc="http://schemas.openxmlformats.org/markup-compatibility/2006" xmlns:mv="urn:schemas-microsoft-com:mac:vml" xmlns:o="urn:schemas-microsoft-com:office:office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:ma14="http://schemas.microsoft.com/office/mac/drawingml/2011/main" xmlns:lc="http://schemas.openxmlformats.org/drawingml/2006/lockedCanvas"/>
            </a:ext>
          </a:extLst>
        </p:spPr>
      </p:pic>
      <p:sp>
        <p:nvSpPr>
          <p:cNvPr id="7" name="TextBox 6"/>
          <p:cNvSpPr txBox="1"/>
          <p:nvPr/>
        </p:nvSpPr>
        <p:spPr>
          <a:xfrm rot="18646673">
            <a:off x="4116862" y="1909183"/>
            <a:ext cx="561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MC58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646673">
            <a:off x="4431781" y="1756466"/>
            <a:ext cx="9621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MC58</a:t>
            </a:r>
            <a:r>
              <a:rPr lang="en-GB" sz="1100" dirty="0" smtClean="0">
                <a:latin typeface="Symbol" pitchFamily="18" charset="2"/>
                <a:cs typeface="Arial" pitchFamily="34" charset="0"/>
              </a:rPr>
              <a:t>D</a:t>
            </a:r>
            <a:r>
              <a:rPr lang="en-GB" sz="1100" i="1" dirty="0" smtClean="0">
                <a:latin typeface="Arial" pitchFamily="34" charset="0"/>
                <a:cs typeface="Arial" pitchFamily="34" charset="0"/>
              </a:rPr>
              <a:t>fHbp</a:t>
            </a:r>
            <a:endParaRPr lang="en-GB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646673">
            <a:off x="4845918" y="1809943"/>
            <a:ext cx="7873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fHbp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v1.1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92696" y="161967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02314" y="34198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30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of. S. Lea</dc:creator>
  <cp:lastModifiedBy>Chris</cp:lastModifiedBy>
  <cp:revision>17</cp:revision>
  <dcterms:created xsi:type="dcterms:W3CDTF">2012-04-13T09:29:00Z</dcterms:created>
  <dcterms:modified xsi:type="dcterms:W3CDTF">2012-09-26T20:27:33Z</dcterms:modified>
</cp:coreProperties>
</file>